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" userDrawn="1">
          <p15:clr>
            <a:srgbClr val="A4A3A4"/>
          </p15:clr>
        </p15:guide>
        <p15:guide id="2" pos="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14" y="108"/>
      </p:cViewPr>
      <p:guideLst>
        <p:guide orient="horz" pos="51"/>
        <p:guide pos="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9824B9-6AFF-6FBA-B1AF-2946C89522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896A97B-77C5-5BA1-470C-F22A8FC922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869ED7-EC01-23AE-3416-0E29088C7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413CB7-9113-B98A-6ACF-63065DD02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B0914C-2D39-883B-B122-F677AE95F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714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561AE9-C3A1-CF54-F03F-AB6FDA0405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D89F326-615E-5FAE-B203-EE2EFA4FEA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ECFFE1-031E-E810-EC5D-EB7D0D5E2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D44F84-91E0-F9CB-A2A7-C7239B525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A10DC3-EC00-8ECE-686D-C4798F24F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37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FE647DE-9761-6EDA-BE08-F2EFC91347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12E6F8-25AD-9BA6-8875-567B0F6505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866ACE-A008-1B0C-D8E6-E604B1989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A2D493-DA1E-3D7E-B711-DB2EFF14B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66F0EE-4BB1-3757-8B7E-818723C4E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302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F1FBB9-A614-32DF-3019-50A5FF78D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393B9-F880-896A-FE95-6A19EB25EE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21130E-0385-FC1A-AE09-D1D832C7D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66600E-B47B-E7AC-F2A7-45CB517BF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CAAAE1-F5CD-D3F9-9EA7-65872CAAD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93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8E0FB6-1111-1C16-36CA-DABE4EB6D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5478F6-2AED-F1A0-F6C0-61061BD994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ABB955F-2ADE-9783-8EAE-295AD222A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55483C-7127-2EE5-00CB-EF94BE9F9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E24709-4A06-EDC0-53A9-B6278EAF5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4535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0E1181-E9B9-16C3-91B0-54BCA70C3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B3BBEED-7C12-9105-0BCD-1F49A43151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8013C55-2DC9-0973-4D5E-9CE53A208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BF9450-63CD-D169-6FF7-300A536FB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2132B6-BBEB-CB25-AA0F-49677FF9B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C2FCC12-3F17-DCA5-EF03-19769E8B4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5681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6C60D8-5D28-296F-E248-0DCA8BBA6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0A962A-AB29-4C9E-D073-BC959EDE38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64DBEB-EC9D-BD45-DB81-5287BD4AFB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DE4748A-9ACA-030E-E210-8AF7AEE6B2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6CA5CA2-9058-C097-EC67-B2C364BBC3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AAB86BB-BF9D-DB58-39D0-547DE688D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F44DF6A-B85C-A53B-3493-4F797F81F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60E6742-F524-6937-D2CD-EAB4BD70A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008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40E123-07B6-D076-6714-24F8FC9A9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41535E-910E-46BD-16F3-952B5F6B2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59047F3-774D-4710-C9DB-B1653B741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C0CA5B5-2A47-C1A7-C14E-68E3DFC5C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878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7484E81-9381-81D9-5F9B-0B0E5FE1E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9750D2-B545-7A94-A2C0-6B7A50F07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65462C0-CD80-816F-6E74-E12F64B70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668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E6A7BF-9B23-2CA5-7062-B6FDED21F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ED193CD-592F-BD80-A288-FE8F09133E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60B9F0-1136-1164-1CA4-307BF0D921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1095423-43B1-5731-FAE0-FF4064D13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86772E3-6161-4251-2CF2-E9C6B63BA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E0C021-183D-37F7-E06C-A3085E090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337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0E6D54-6216-35E6-FB54-7F7606B6B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46E7818-EA78-1887-B006-FD7F4B205B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B3E277-82E3-390A-E835-7F6AC0D7F3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3CE0D9D-10DF-1E18-8C82-4795E3DD6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15B467-E8AE-C4F0-95FA-71A8736F2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94617E-7A07-27C2-99B6-C796AB78D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3083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C2388EE-CF4C-9E3C-3C7E-233FC9F138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8255AF-5270-E548-386F-F23C60320B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87A86C-EDF4-5BA6-728E-107D664F57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FE859-AEC4-4728-BC59-6BE512CBF96F}" type="datetimeFigureOut">
              <a:rPr lang="zh-CN" altLang="en-US" smtClean="0"/>
              <a:t>2024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343B57-BB5A-FF8B-B342-B82988B705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3A13F6-4A9B-2E16-BC8F-75B3079FA5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2DC50-DCFA-45BF-AEFC-DF5806F23E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111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1E01E434-4C53-B5B9-1F0D-7692D9BB6C4D}"/>
              </a:ext>
            </a:extLst>
          </p:cNvPr>
          <p:cNvSpPr txBox="1"/>
          <p:nvPr/>
        </p:nvSpPr>
        <p:spPr>
          <a:xfrm>
            <a:off x="746621" y="1904954"/>
            <a:ext cx="10838575" cy="22224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lonic microflora and plasma metabolite-based comparative analysis of unilateral ureteral obstruction-induced chronic kidney disease after treatment with the Chinese medicine </a:t>
            </a:r>
            <a:r>
              <a:rPr lang="en-US" altLang="zh-CN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uZhengHuaYuJiangZhuTongLuo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nd AST-120</a:t>
            </a:r>
          </a:p>
          <a:p>
            <a:pPr algn="ctr">
              <a:lnSpc>
                <a:spcPct val="200000"/>
              </a:lnSpc>
            </a:pP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Original Images)</a:t>
            </a:r>
            <a:endParaRPr lang="zh-CN" altLang="zh-CN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433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64FC328-3913-3450-CCD6-7843F9E174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7030" y="2046811"/>
            <a:ext cx="2048256" cy="167030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0540479-37AE-D6DA-4A06-D35C8B115C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7030" y="3771279"/>
            <a:ext cx="2048256" cy="167030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60D6651-A126-E99D-F5B5-5DA8BFD588A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7030" y="312482"/>
            <a:ext cx="2048256" cy="1670304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248BD8AF-0B3E-CBC8-AAD5-CB21411D23F0}"/>
              </a:ext>
            </a:extLst>
          </p:cNvPr>
          <p:cNvSpPr txBox="1"/>
          <p:nvPr/>
        </p:nvSpPr>
        <p:spPr>
          <a:xfrm>
            <a:off x="3932766" y="2667451"/>
            <a:ext cx="8307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272A679-1601-8744-A7BE-5E2780AA6A3A}"/>
              </a:ext>
            </a:extLst>
          </p:cNvPr>
          <p:cNvSpPr txBox="1"/>
          <p:nvPr/>
        </p:nvSpPr>
        <p:spPr>
          <a:xfrm>
            <a:off x="4132484" y="997147"/>
            <a:ext cx="6310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CBB6D05-F7F0-28C7-16CC-D31EF1DA88C9}"/>
              </a:ext>
            </a:extLst>
          </p:cNvPr>
          <p:cNvSpPr txBox="1"/>
          <p:nvPr/>
        </p:nvSpPr>
        <p:spPr>
          <a:xfrm>
            <a:off x="4057333" y="4491015"/>
            <a:ext cx="7142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2A50A45-8340-3D3C-EFE2-1761B6DFFA5B}"/>
              </a:ext>
            </a:extLst>
          </p:cNvPr>
          <p:cNvSpPr txBox="1"/>
          <p:nvPr/>
        </p:nvSpPr>
        <p:spPr>
          <a:xfrm rot="18900000">
            <a:off x="4994552" y="5472376"/>
            <a:ext cx="6405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44B6AB2-8FFB-3BC3-8E68-37BF5143993F}"/>
              </a:ext>
            </a:extLst>
          </p:cNvPr>
          <p:cNvSpPr txBox="1"/>
          <p:nvPr/>
        </p:nvSpPr>
        <p:spPr>
          <a:xfrm rot="18900000">
            <a:off x="5296298" y="5482479"/>
            <a:ext cx="500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UO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E4693CC-3A93-21D3-610F-6FDCB38AA30D}"/>
              </a:ext>
            </a:extLst>
          </p:cNvPr>
          <p:cNvSpPr txBox="1"/>
          <p:nvPr/>
        </p:nvSpPr>
        <p:spPr>
          <a:xfrm rot="18900000">
            <a:off x="5165108" y="5599182"/>
            <a:ext cx="10333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UO+FZHY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E154F5A-1020-85E7-7F0D-C36C50D276F0}"/>
              </a:ext>
            </a:extLst>
          </p:cNvPr>
          <p:cNvSpPr txBox="1"/>
          <p:nvPr/>
        </p:nvSpPr>
        <p:spPr>
          <a:xfrm rot="18900000">
            <a:off x="5285844" y="5644783"/>
            <a:ext cx="11839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UUO+AST-12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460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9</Words>
  <Application>Microsoft Office PowerPoint</Application>
  <PresentationFormat>宽屏</PresentationFormat>
  <Paragraphs>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 H</dc:creator>
  <cp:lastModifiedBy>Administrator H</cp:lastModifiedBy>
  <cp:revision>4</cp:revision>
  <dcterms:created xsi:type="dcterms:W3CDTF">2024-01-17T06:53:51Z</dcterms:created>
  <dcterms:modified xsi:type="dcterms:W3CDTF">2024-01-17T07:36:26Z</dcterms:modified>
</cp:coreProperties>
</file>